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D38739-84CA-40CA-94C6-78E64040E3B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6EBF88-A943-42B5-AF1E-E6B14B78C61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626F37-34C1-46FA-AD87-571FAAEF2A4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D42E7E-D965-432A-AAA2-1DDD4BEB091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5F3803-1A61-4B10-BAF8-2F12F73745B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E6E9B9-68A2-46A7-B638-6816C587F51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B5AC36-F232-448E-803A-497808D1694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114086-6E55-414D-BFE5-D2ABEC060CA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E9D89F-9E50-4E2B-B00E-7F9E7F5E6F1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1DA034-C546-4E47-A4FC-2066BCA04D1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764EC0-679C-432E-9207-899A4CBA778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D7A37C-1D59-4D10-8415-7BDC2410535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0160"/>
            <a:ext cx="217152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F830563-E0BC-4166-8414-55816578EA83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1268280" y="1281240"/>
          <a:ext cx="4010040" cy="2369880"/>
        </p:xfrm>
        <a:graphic>
          <a:graphicData uri="http://schemas.openxmlformats.org/drawingml/2006/table">
            <a:tbl>
              <a:tblPr/>
              <a:tblGrid>
                <a:gridCol w="1822680"/>
                <a:gridCol w="625320"/>
                <a:gridCol w="814320"/>
                <a:gridCol w="747720"/>
              </a:tblGrid>
              <a:tr h="270000">
                <a:tc rowSpan="2"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7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In situ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2"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Invasive carcinom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49032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ohort 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ohort 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4748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atients collected for study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1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2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1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4712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atients with tissue available for array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8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2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1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6856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umors stained for </a:t>
                      </a: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IAH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9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8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4640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umors with </a:t>
                      </a: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IAH2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staining and survival dat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4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2-08T21:15:31Z</dcterms:created>
  <dc:creator>amoeller</dc:creator>
  <dc:description/>
  <dc:language>en-US</dc:language>
  <cp:lastModifiedBy>amoeller</cp:lastModifiedBy>
  <dcterms:modified xsi:type="dcterms:W3CDTF">2011-02-08T21:31:45Z</dcterms:modified>
  <cp:revision>2</cp:revision>
  <dc:subject/>
  <dc:title>Slide 1</dc:title>
</cp:coreProperties>
</file>